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svg" ContentType="image/svg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60" r:id="rId3"/>
    <p:sldId id="261" r:id="rId4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8F9292"/>
    <a:srgbClr val="606464"/>
    <a:srgbClr val="9B86AC"/>
    <a:srgbClr val="715389"/>
    <a:srgbClr val="67A076"/>
    <a:srgbClr val="26783C"/>
    <a:srgbClr val="5E88A4"/>
    <a:srgbClr val="1A567D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C971EDB3-17EE-4D12-A968-D2346E7DD37B}" v="2" dt="2025-12-10T16:06:36.895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123" d="100"/>
          <a:sy n="123" d="100"/>
        </p:scale>
        <p:origin x="114" y="18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10" Type="http://schemas.microsoft.com/office/2015/10/relationships/revisionInfo" Target="revisionInfo.xml"/><Relationship Id="rId4" Type="http://schemas.openxmlformats.org/officeDocument/2006/relationships/slide" Target="slides/slide3.xml"/><Relationship Id="rId9" Type="http://schemas.microsoft.com/office/2016/11/relationships/changesInfo" Target="changesInfos/changesInfo1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Bondt, A. (Albert)" userId="f6abbfb7-edb4-47c9-b9ee-b4dcf2354f0d" providerId="ADAL" clId="{C971EDB3-17EE-4D12-A968-D2346E7DD37B}"/>
    <pc:docChg chg="custSel delSld modSld">
      <pc:chgData name="Bondt, A. (Albert)" userId="f6abbfb7-edb4-47c9-b9ee-b4dcf2354f0d" providerId="ADAL" clId="{C971EDB3-17EE-4D12-A968-D2346E7DD37B}" dt="2025-12-10T16:06:52.116" v="48" actId="6549"/>
      <pc:docMkLst>
        <pc:docMk/>
      </pc:docMkLst>
      <pc:sldChg chg="delSp modSp mod">
        <pc:chgData name="Bondt, A. (Albert)" userId="f6abbfb7-edb4-47c9-b9ee-b4dcf2354f0d" providerId="ADAL" clId="{C971EDB3-17EE-4D12-A968-D2346E7DD37B}" dt="2025-12-10T16:06:52.116" v="48" actId="6549"/>
        <pc:sldMkLst>
          <pc:docMk/>
          <pc:sldMk cId="1199333380" sldId="256"/>
        </pc:sldMkLst>
        <pc:spChg chg="mod">
          <ac:chgData name="Bondt, A. (Albert)" userId="f6abbfb7-edb4-47c9-b9ee-b4dcf2354f0d" providerId="ADAL" clId="{C971EDB3-17EE-4D12-A968-D2346E7DD37B}" dt="2025-12-10T16:06:52.116" v="48" actId="6549"/>
          <ac:spMkLst>
            <pc:docMk/>
            <pc:sldMk cId="1199333380" sldId="256"/>
            <ac:spMk id="2" creationId="{52EFBF44-9A34-5782-8817-4FF1D99EC12A}"/>
          </ac:spMkLst>
        </pc:spChg>
        <pc:spChg chg="del mod">
          <ac:chgData name="Bondt, A. (Albert)" userId="f6abbfb7-edb4-47c9-b9ee-b4dcf2354f0d" providerId="ADAL" clId="{C971EDB3-17EE-4D12-A968-D2346E7DD37B}" dt="2025-12-10T16:05:58.750" v="29" actId="478"/>
          <ac:spMkLst>
            <pc:docMk/>
            <pc:sldMk cId="1199333380" sldId="256"/>
            <ac:spMk id="3" creationId="{1BE819C1-F6D8-86D8-5126-869DCDFD76D0}"/>
          </ac:spMkLst>
        </pc:spChg>
      </pc:sldChg>
      <pc:sldChg chg="del">
        <pc:chgData name="Bondt, A. (Albert)" userId="f6abbfb7-edb4-47c9-b9ee-b4dcf2354f0d" providerId="ADAL" clId="{C971EDB3-17EE-4D12-A968-D2346E7DD37B}" dt="2025-12-10T16:03:38.793" v="0" actId="47"/>
        <pc:sldMkLst>
          <pc:docMk/>
          <pc:sldMk cId="50246677" sldId="257"/>
        </pc:sldMkLst>
      </pc:sldChg>
      <pc:sldChg chg="del">
        <pc:chgData name="Bondt, A. (Albert)" userId="f6abbfb7-edb4-47c9-b9ee-b4dcf2354f0d" providerId="ADAL" clId="{C971EDB3-17EE-4D12-A968-D2346E7DD37B}" dt="2025-12-10T16:03:38.793" v="0" actId="47"/>
        <pc:sldMkLst>
          <pc:docMk/>
          <pc:sldMk cId="1184326479" sldId="258"/>
        </pc:sldMkLst>
      </pc:sldChg>
      <pc:sldChg chg="del">
        <pc:chgData name="Bondt, A. (Albert)" userId="f6abbfb7-edb4-47c9-b9ee-b4dcf2354f0d" providerId="ADAL" clId="{C971EDB3-17EE-4D12-A968-D2346E7DD37B}" dt="2025-12-10T16:03:38.793" v="0" actId="47"/>
        <pc:sldMkLst>
          <pc:docMk/>
          <pc:sldMk cId="3059373840" sldId="259"/>
        </pc:sldMkLst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EC15FB4-3F24-5A80-7A0E-07179C8553B7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0408562D-AA2B-B51E-F560-7639777F9C1B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7E9884D-1C84-1A9F-E059-E48238A5534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691172-F654-4975-8DB7-F0F1F2819036}" type="datetimeFigureOut">
              <a:rPr lang="en-US" smtClean="0"/>
              <a:t>10-Dec-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BBF513F-DD8F-D9FB-0609-3F45F7D7425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0F0B724-B9DB-7898-BB4D-7D94BDBCAB4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8D5BED-BAB4-4582-AC4C-2643AF50FA2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6695025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EA67986-A749-B03C-B548-7F54A5C5862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75D14C07-8EEB-A2BD-4E7A-D90A630EC3A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98EBF09-BD12-3A1F-035F-9C6C81FA21A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691172-F654-4975-8DB7-F0F1F2819036}" type="datetimeFigureOut">
              <a:rPr lang="en-US" smtClean="0"/>
              <a:t>10-Dec-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5B02373-6190-952A-14FD-76DDE62081C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C83BC1F-490C-5079-7B1F-5C02E999F54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8D5BED-BAB4-4582-AC4C-2643AF50FA2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7388738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7CBCF6F3-DB4E-71D3-36FF-C7CE75ECB045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702FF892-C549-7108-12B8-DA643B272EE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C85D3A1-A2EE-ABD1-9F3C-AEA17F7752A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691172-F654-4975-8DB7-F0F1F2819036}" type="datetimeFigureOut">
              <a:rPr lang="en-US" smtClean="0"/>
              <a:t>10-Dec-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9EFA2FB-79FD-11F3-F024-7C00105FF06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FABB578-36EE-BFBA-817A-115E2DEE4A6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8D5BED-BAB4-4582-AC4C-2643AF50FA2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038604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6FC3437-5D57-81AF-EDED-EDFA502704C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0106A25-8BD3-E2FF-FCFF-0F5B9C9C09E7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81C9998-58AF-16CB-7977-28BAF2165C5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691172-F654-4975-8DB7-F0F1F2819036}" type="datetimeFigureOut">
              <a:rPr lang="en-US" smtClean="0"/>
              <a:t>10-Dec-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BD83251-998B-915D-ABD1-5CCBF330F88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40A261A-509C-01DB-452D-020BD468307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8D5BED-BAB4-4582-AC4C-2643AF50FA2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5316405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AEC4C68-8A24-52EB-D7BA-DB2A2144AC2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89EFBE8F-60A8-EBE6-8176-8ED52646648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A8D0643-808E-8A46-F88B-F5B60C3A877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691172-F654-4975-8DB7-F0F1F2819036}" type="datetimeFigureOut">
              <a:rPr lang="en-US" smtClean="0"/>
              <a:t>10-Dec-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0AD7F1F-4DEA-56F1-8990-D705E5170AA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C99942D-BC0A-DB54-4BB6-A3395D8A85B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8D5BED-BAB4-4582-AC4C-2643AF50FA2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8099395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BE14B4C-4BF2-8930-F782-8CF80C44CC5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3928194-C062-227F-4EED-772CCA66C545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BB7C6EBA-AA2F-24EF-7146-1260C87FE6C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E9150F4A-CF72-22C0-4512-C224BFF933B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691172-F654-4975-8DB7-F0F1F2819036}" type="datetimeFigureOut">
              <a:rPr lang="en-US" smtClean="0"/>
              <a:t>10-Dec-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2670B8CB-065E-1E7D-974E-5CB36DF4D02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A55375E3-BE03-45DD-3906-CBD4291055F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8D5BED-BAB4-4582-AC4C-2643AF50FA2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4198436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57FD763-5961-5EEA-F840-3D27A641E68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44FB532E-678D-C5A0-ECF5-90B92A38CFD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4DE024C4-1DE8-F520-F70B-BCB40EBA4B4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95B2CF6B-57AD-DFC8-1092-F8DC83CC64D6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82DB480C-15ED-8D89-49B6-A80D547E5CE9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36529931-8618-D797-4324-F86794E28C2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691172-F654-4975-8DB7-F0F1F2819036}" type="datetimeFigureOut">
              <a:rPr lang="en-US" smtClean="0"/>
              <a:t>10-Dec-25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768F8481-5677-92D0-2573-907AF15023E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1E300CAA-AFF0-5384-6CC7-F8AEAA709D4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8D5BED-BAB4-4582-AC4C-2643AF50FA2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0755200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9CF2DC6-9B70-CF99-EAB7-40A37DE72E1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8ACF4611-C92D-A298-98B8-BF0B98D674E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691172-F654-4975-8DB7-F0F1F2819036}" type="datetimeFigureOut">
              <a:rPr lang="en-US" smtClean="0"/>
              <a:t>10-Dec-25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769E8027-7C84-2F90-AAAA-8969BECFF88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8616C2D0-4B0C-7CB3-92D5-63E87A7DD9B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8D5BED-BAB4-4582-AC4C-2643AF50FA2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0488778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29A2A5FF-4833-8BC1-30A4-B1E018A3E1D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691172-F654-4975-8DB7-F0F1F2819036}" type="datetimeFigureOut">
              <a:rPr lang="en-US" smtClean="0"/>
              <a:t>10-Dec-25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1A272AD4-A7B3-9B89-ED33-87ACF72620D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D790D967-5B32-6535-D975-A071AE5C5ED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8D5BED-BAB4-4582-AC4C-2643AF50FA2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7482879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8B9C823-CAA0-5D50-A654-59CC7448A09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30203EE-9C91-B782-509D-B91022956916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5D01D705-114B-6E3E-AE68-CFBB65B511A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8F1098C8-A833-B999-3053-2B6B12C8D9F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691172-F654-4975-8DB7-F0F1F2819036}" type="datetimeFigureOut">
              <a:rPr lang="en-US" smtClean="0"/>
              <a:t>10-Dec-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194362D0-0E3A-5B73-52CD-6ACC333145F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BDF0D34E-85C2-BBE4-20B1-DCE35EB681D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8D5BED-BAB4-4582-AC4C-2643AF50FA2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4773109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EBCC796-1C14-1B13-BF23-A736F0FE801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9D15B66A-CC8F-7B03-0227-AF674CF6A483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2B802328-EEDF-FC03-9054-17D1BC297D9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F4A2CC10-D497-2B72-D1D4-415B22E923B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691172-F654-4975-8DB7-F0F1F2819036}" type="datetimeFigureOut">
              <a:rPr lang="en-US" smtClean="0"/>
              <a:t>10-Dec-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18B5B939-37CB-8FB0-4964-FED1AB1409C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71E490C3-968B-B443-3A2E-8AA4E5ACCB2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8D5BED-BAB4-4582-AC4C-2643AF50FA2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588574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83A7CB27-8914-1351-FFE6-2D2F6147001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025614E2-B9D3-B04A-355A-66D12A4B930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E6B0430-6ADB-B918-61C4-CD34665760A4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44691172-F654-4975-8DB7-F0F1F2819036}" type="datetimeFigureOut">
              <a:rPr lang="en-US" smtClean="0"/>
              <a:t>10-Dec-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69A5EE5-33DB-969A-6BE1-F20A1DABA2D0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ADAB82D-05BA-75BF-B42F-3B2463BB3610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0A8D5BED-BAB4-4582-AC4C-2643AF50FA2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9703608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hyperlink" Target="mailto:guojjhu@163.com" TargetMode="External"/><Relationship Id="rId2" Type="http://schemas.openxmlformats.org/officeDocument/2006/relationships/hyperlink" Target="mailto:a.j.r.heck@uu.nl" TargetMode="External"/><Relationship Id="rId1" Type="http://schemas.openxmlformats.org/officeDocument/2006/relationships/slideLayout" Target="../slideLayouts/slideLayout1.xml"/><Relationship Id="rId4" Type="http://schemas.openxmlformats.org/officeDocument/2006/relationships/hyperlink" Target="mailto:zhujing@bjast.ac.cn" TargetMode="Externa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sv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svg"/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2EFBF44-9A34-5782-8817-4FF1D99EC12A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2"/>
            <a:ext cx="9144000" cy="3705360"/>
          </a:xfrm>
        </p:spPr>
        <p:txBody>
          <a:bodyPr>
            <a:normAutofit fontScale="90000"/>
          </a:bodyPr>
          <a:lstStyle/>
          <a:p>
            <a:r>
              <a:rPr lang="en-US" sz="4400" b="1" dirty="0"/>
              <a:t>Supplemental Figures to:</a:t>
            </a:r>
            <a:br>
              <a:rPr lang="en-US" sz="4400" b="1" dirty="0"/>
            </a:br>
            <a:r>
              <a:rPr lang="en-US" sz="4900" dirty="0"/>
              <a:t>Dissecting infant and maternal antibody repertoires exposes the early onset of infant humoral immunity</a:t>
            </a:r>
            <a:br>
              <a:rPr lang="en-US" sz="4900" dirty="0"/>
            </a:br>
            <a:br>
              <a:rPr lang="en-US" sz="4900" dirty="0"/>
            </a:br>
            <a:r>
              <a:rPr lang="en-US" sz="1800" dirty="0"/>
              <a:t>Correspondence to Prof. Albert J.R. Heck (</a:t>
            </a:r>
            <a:r>
              <a:rPr lang="en-US" sz="1800" u="sng" dirty="0">
                <a:hlinkClick r:id="rId2"/>
              </a:rPr>
              <a:t>a.j.r.heck@uu.nl</a:t>
            </a:r>
            <a:r>
              <a:rPr lang="en-US" sz="1800" dirty="0"/>
              <a:t>) or Prof. </a:t>
            </a:r>
            <a:r>
              <a:rPr lang="en-US" sz="1800" dirty="0" err="1"/>
              <a:t>Juanjuan</a:t>
            </a:r>
            <a:r>
              <a:rPr lang="en-US" sz="1800" dirty="0"/>
              <a:t> Guo (</a:t>
            </a:r>
            <a:r>
              <a:rPr lang="en-US" sz="1800" u="sng" dirty="0">
                <a:hlinkClick r:id="rId3"/>
              </a:rPr>
              <a:t>guojjhu@163.com</a:t>
            </a:r>
            <a:r>
              <a:rPr lang="en-US" sz="1800" dirty="0"/>
              <a:t>) or Dr. Jing Zhu (</a:t>
            </a:r>
            <a:r>
              <a:rPr lang="en-US" sz="1800" u="sng" dirty="0">
                <a:hlinkClick r:id="rId4"/>
              </a:rPr>
              <a:t>zhujing@bjast.ac.cn</a:t>
            </a:r>
            <a:r>
              <a:rPr lang="en-US" sz="1800" dirty="0"/>
              <a:t>)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19933338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18B491C-B968-1955-AC04-42284131F2D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Supp Fig 1 – IgA1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6BC48872-6869-72BB-E683-307BC5FF0EEA}"/>
              </a:ext>
            </a:extLst>
          </p:cNvPr>
          <p:cNvSpPr txBox="1"/>
          <p:nvPr/>
        </p:nvSpPr>
        <p:spPr>
          <a:xfrm>
            <a:off x="186496" y="3932319"/>
            <a:ext cx="6096000" cy="2062103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400" b="1" dirty="0">
                <a:effectLst/>
                <a:latin typeface="Aptos" panose="020B0004020202020204" pitchFamily="34" charset="0"/>
                <a:ea typeface="DengXian" panose="02010600030101010101" pitchFamily="2" charset="-122"/>
                <a:cs typeface="Arial" panose="020B0604020202020204" pitchFamily="34" charset="0"/>
              </a:rPr>
              <a:t>Supplementary Figure 1 | Infant IgA1 is unique and produced early on in the newborn.</a:t>
            </a:r>
            <a:r>
              <a:rPr lang="en-US" sz="1600" dirty="0">
                <a:effectLst/>
                <a:latin typeface="Aptos" panose="020B0004020202020204" pitchFamily="34" charset="0"/>
                <a:ea typeface="DengXian" panose="02010600030101010101" pitchFamily="2" charset="-122"/>
                <a:cs typeface="Arial" panose="020B0604020202020204" pitchFamily="34" charset="0"/>
              </a:rPr>
              <a:t> </a:t>
            </a:r>
            <a:r>
              <a:rPr lang="en-US" sz="1400" dirty="0">
                <a:effectLst/>
                <a:latin typeface="Aptos" panose="020B0004020202020204" pitchFamily="34" charset="0"/>
                <a:ea typeface="DengXian" panose="02010600030101010101" pitchFamily="2" charset="-122"/>
                <a:cs typeface="Arial" panose="020B0604020202020204" pitchFamily="34" charset="0"/>
              </a:rPr>
              <a:t>Detailed visualization of the repertoires [from donor dyad 1 (</a:t>
            </a:r>
            <a:r>
              <a:rPr lang="en-US" sz="1400" b="1" dirty="0">
                <a:effectLst/>
                <a:latin typeface="Aptos" panose="020B0004020202020204" pitchFamily="34" charset="0"/>
                <a:ea typeface="DengXian" panose="02010600030101010101" pitchFamily="2" charset="-122"/>
                <a:cs typeface="Arial" panose="020B0604020202020204" pitchFamily="34" charset="0"/>
              </a:rPr>
              <a:t>a</a:t>
            </a:r>
            <a:r>
              <a:rPr lang="en-US" sz="1400" dirty="0">
                <a:effectLst/>
                <a:latin typeface="Aptos" panose="020B0004020202020204" pitchFamily="34" charset="0"/>
                <a:ea typeface="DengXian" panose="02010600030101010101" pitchFamily="2" charset="-122"/>
                <a:cs typeface="Arial" panose="020B0604020202020204" pitchFamily="34" charset="0"/>
              </a:rPr>
              <a:t>), donor dyad 2 (</a:t>
            </a:r>
            <a:r>
              <a:rPr lang="en-US" sz="1400" b="1" dirty="0">
                <a:effectLst/>
                <a:latin typeface="Aptos" panose="020B0004020202020204" pitchFamily="34" charset="0"/>
                <a:ea typeface="DengXian" panose="02010600030101010101" pitchFamily="2" charset="-122"/>
                <a:cs typeface="Arial" panose="020B0604020202020204" pitchFamily="34" charset="0"/>
              </a:rPr>
              <a:t>b</a:t>
            </a:r>
            <a:r>
              <a:rPr lang="en-US" sz="1400" dirty="0">
                <a:effectLst/>
                <a:latin typeface="Aptos" panose="020B0004020202020204" pitchFamily="34" charset="0"/>
                <a:ea typeface="DengXian" panose="02010600030101010101" pitchFamily="2" charset="-122"/>
                <a:cs typeface="Arial" panose="020B0604020202020204" pitchFamily="34" charset="0"/>
              </a:rPr>
              <a:t>), and donor dyad 4 (</a:t>
            </a:r>
            <a:r>
              <a:rPr lang="en-US" sz="1400" b="1" dirty="0">
                <a:effectLst/>
                <a:latin typeface="Aptos" panose="020B0004020202020204" pitchFamily="34" charset="0"/>
                <a:ea typeface="DengXian" panose="02010600030101010101" pitchFamily="2" charset="-122"/>
                <a:cs typeface="Arial" panose="020B0604020202020204" pitchFamily="34" charset="0"/>
              </a:rPr>
              <a:t>c</a:t>
            </a:r>
            <a:r>
              <a:rPr lang="en-US" sz="1400" dirty="0">
                <a:effectLst/>
                <a:latin typeface="Aptos" panose="020B0004020202020204" pitchFamily="34" charset="0"/>
                <a:ea typeface="DengXian" panose="02010600030101010101" pitchFamily="2" charset="-122"/>
                <a:cs typeface="Arial" panose="020B0604020202020204" pitchFamily="34" charset="0"/>
              </a:rPr>
              <a:t>)] show the high similarity between maternal serum (red) and milk samples (blue), whereas the infant repertoires (orange) are distinct. </a:t>
            </a:r>
          </a:p>
          <a:p>
            <a:r>
              <a:rPr lang="en-US" sz="1400" dirty="0">
                <a:effectLst/>
                <a:latin typeface="Aptos" panose="020B0004020202020204" pitchFamily="34" charset="0"/>
                <a:ea typeface="DengXian" panose="02010600030101010101" pitchFamily="2" charset="-122"/>
                <a:cs typeface="Arial" panose="020B0604020202020204" pitchFamily="34" charset="0"/>
              </a:rPr>
              <a:t>In this representation each vertical line represents a single clone at its detected mass (x-axis), and the y-axis represents the detected intensity. The </a:t>
            </a:r>
            <a:r>
              <a:rPr lang="en-US" sz="1400" dirty="0" err="1">
                <a:effectLst/>
                <a:latin typeface="Aptos" panose="020B0004020202020204" pitchFamily="34" charset="0"/>
                <a:ea typeface="DengXian" panose="02010600030101010101" pitchFamily="2" charset="-122"/>
                <a:cs typeface="Arial" panose="020B0604020202020204" pitchFamily="34" charset="0"/>
              </a:rPr>
              <a:t>r-values</a:t>
            </a:r>
            <a:r>
              <a:rPr lang="en-US" sz="1400" dirty="0">
                <a:effectLst/>
                <a:latin typeface="Aptos" panose="020B0004020202020204" pitchFamily="34" charset="0"/>
                <a:ea typeface="DengXian" panose="02010600030101010101" pitchFamily="2" charset="-122"/>
                <a:cs typeface="Arial" panose="020B0604020202020204" pitchFamily="34" charset="0"/>
              </a:rPr>
              <a:t> in the dendrograms at the right of these “mass plots” further illustrate the dissimilarity of the infant serum.</a:t>
            </a:r>
            <a:endParaRPr lang="en-US" sz="1400" dirty="0"/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7678614B-77D2-A5D2-0CA8-64445A1C3243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96DAC541-7B7A-43D3-8B79-37D633B846F1}">
                <asvg:svgBlip xmlns:asvg="http://schemas.microsoft.com/office/drawing/2016/SVG/main" r:embed="rId3"/>
              </a:ext>
            </a:extLst>
          </a:blip>
          <a:srcRect/>
          <a:stretch/>
        </p:blipFill>
        <p:spPr>
          <a:xfrm>
            <a:off x="6514048" y="441707"/>
            <a:ext cx="4783992" cy="582218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552335641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22A343D8-FDFF-332F-66D3-A59B60A753E7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96DAC541-7B7A-43D3-8B79-37D633B846F1}">
                <asvg:svgBlip xmlns:asvg="http://schemas.microsoft.com/office/drawing/2016/SVG/main" r:embed="rId3"/>
              </a:ext>
            </a:extLst>
          </a:blip>
          <a:srcRect/>
          <a:stretch/>
        </p:blipFill>
        <p:spPr>
          <a:xfrm>
            <a:off x="5978306" y="395977"/>
            <a:ext cx="5245822" cy="6066046"/>
          </a:xfrm>
          <a:prstGeom prst="rect">
            <a:avLst/>
          </a:prstGeom>
        </p:spPr>
      </p:pic>
      <p:sp>
        <p:nvSpPr>
          <p:cNvPr id="2" name="Title 1">
            <a:extLst>
              <a:ext uri="{FF2B5EF4-FFF2-40B4-BE49-F238E27FC236}">
                <a16:creationId xmlns:a16="http://schemas.microsoft.com/office/drawing/2014/main" id="{08B8A721-74CC-398F-16BE-AB065F5B4D3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Supp fig 2 – IgG1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9BB0FABA-AC4F-4070-CAE0-60F047FC58C3}"/>
              </a:ext>
            </a:extLst>
          </p:cNvPr>
          <p:cNvSpPr txBox="1"/>
          <p:nvPr/>
        </p:nvSpPr>
        <p:spPr>
          <a:xfrm>
            <a:off x="176214" y="3977551"/>
            <a:ext cx="5405436" cy="249299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400" b="1" dirty="0">
                <a:effectLst/>
                <a:latin typeface="Aptos" panose="020B0004020202020204" pitchFamily="34" charset="0"/>
                <a:ea typeface="DengXian" panose="02010600030101010101" pitchFamily="2" charset="-122"/>
                <a:cs typeface="Arial" panose="020B0604020202020204" pitchFamily="34" charset="0"/>
              </a:rPr>
              <a:t>Supplementary Figure 2 | Infant IgG1 is unique and produced early on in the newborn.</a:t>
            </a:r>
            <a:r>
              <a:rPr lang="en-US" sz="1600" dirty="0">
                <a:effectLst/>
                <a:latin typeface="Aptos" panose="020B0004020202020204" pitchFamily="34" charset="0"/>
                <a:ea typeface="DengXian" panose="02010600030101010101" pitchFamily="2" charset="-122"/>
                <a:cs typeface="Arial" panose="020B0604020202020204" pitchFamily="34" charset="0"/>
              </a:rPr>
              <a:t> </a:t>
            </a:r>
            <a:r>
              <a:rPr lang="en-US" sz="1400" dirty="0">
                <a:effectLst/>
                <a:latin typeface="Aptos" panose="020B0004020202020204" pitchFamily="34" charset="0"/>
                <a:ea typeface="DengXian" panose="02010600030101010101" pitchFamily="2" charset="-122"/>
                <a:cs typeface="Arial" panose="020B0604020202020204" pitchFamily="34" charset="0"/>
              </a:rPr>
              <a:t>Detailed visualization of the repertoires [from donor dyad 1 (</a:t>
            </a:r>
            <a:r>
              <a:rPr lang="en-US" sz="1400" b="1" dirty="0">
                <a:effectLst/>
                <a:latin typeface="Aptos" panose="020B0004020202020204" pitchFamily="34" charset="0"/>
                <a:ea typeface="DengXian" panose="02010600030101010101" pitchFamily="2" charset="-122"/>
                <a:cs typeface="Arial" panose="020B0604020202020204" pitchFamily="34" charset="0"/>
              </a:rPr>
              <a:t>a</a:t>
            </a:r>
            <a:r>
              <a:rPr lang="en-US" sz="1400" dirty="0">
                <a:effectLst/>
                <a:latin typeface="Aptos" panose="020B0004020202020204" pitchFamily="34" charset="0"/>
                <a:ea typeface="DengXian" panose="02010600030101010101" pitchFamily="2" charset="-122"/>
                <a:cs typeface="Arial" panose="020B0604020202020204" pitchFamily="34" charset="0"/>
              </a:rPr>
              <a:t>), donor dyad 2 (</a:t>
            </a:r>
            <a:r>
              <a:rPr lang="en-US" sz="1400" b="1" dirty="0">
                <a:effectLst/>
                <a:latin typeface="Aptos" panose="020B0004020202020204" pitchFamily="34" charset="0"/>
                <a:ea typeface="DengXian" panose="02010600030101010101" pitchFamily="2" charset="-122"/>
                <a:cs typeface="Arial" panose="020B0604020202020204" pitchFamily="34" charset="0"/>
              </a:rPr>
              <a:t>b</a:t>
            </a:r>
            <a:r>
              <a:rPr lang="en-US" sz="1400" dirty="0">
                <a:effectLst/>
                <a:latin typeface="Aptos" panose="020B0004020202020204" pitchFamily="34" charset="0"/>
                <a:ea typeface="DengXian" panose="02010600030101010101" pitchFamily="2" charset="-122"/>
                <a:cs typeface="Arial" panose="020B0604020202020204" pitchFamily="34" charset="0"/>
              </a:rPr>
              <a:t>), and donor dyad 4 (</a:t>
            </a:r>
            <a:r>
              <a:rPr lang="en-US" sz="1400" b="1" dirty="0">
                <a:effectLst/>
                <a:latin typeface="Aptos" panose="020B0004020202020204" pitchFamily="34" charset="0"/>
                <a:ea typeface="DengXian" panose="02010600030101010101" pitchFamily="2" charset="-122"/>
                <a:cs typeface="Arial" panose="020B0604020202020204" pitchFamily="34" charset="0"/>
              </a:rPr>
              <a:t>c</a:t>
            </a:r>
            <a:r>
              <a:rPr lang="en-US" sz="1400" dirty="0">
                <a:effectLst/>
                <a:latin typeface="Aptos" panose="020B0004020202020204" pitchFamily="34" charset="0"/>
                <a:ea typeface="DengXian" panose="02010600030101010101" pitchFamily="2" charset="-122"/>
                <a:cs typeface="Arial" panose="020B0604020202020204" pitchFamily="34" charset="0"/>
              </a:rPr>
              <a:t>)] show the high similarity between maternal serum (red) and milk samples (blue), whereas the infant repertoires (orange) are distinct. </a:t>
            </a:r>
          </a:p>
          <a:p>
            <a:r>
              <a:rPr lang="en-US" sz="1400" dirty="0">
                <a:effectLst/>
                <a:latin typeface="Aptos" panose="020B0004020202020204" pitchFamily="34" charset="0"/>
                <a:ea typeface="DengXian" panose="02010600030101010101" pitchFamily="2" charset="-122"/>
                <a:cs typeface="Arial" panose="020B0604020202020204" pitchFamily="34" charset="0"/>
              </a:rPr>
              <a:t>In this representation each vertical line represents a single clone at its detected mass (x-axis), and the y-axis represents the detected intensity. The </a:t>
            </a:r>
            <a:r>
              <a:rPr lang="en-US" sz="1400" dirty="0" err="1">
                <a:effectLst/>
                <a:latin typeface="Aptos" panose="020B0004020202020204" pitchFamily="34" charset="0"/>
                <a:ea typeface="DengXian" panose="02010600030101010101" pitchFamily="2" charset="-122"/>
                <a:cs typeface="Arial" panose="020B0604020202020204" pitchFamily="34" charset="0"/>
              </a:rPr>
              <a:t>r-values</a:t>
            </a:r>
            <a:r>
              <a:rPr lang="en-US" sz="1400" dirty="0">
                <a:effectLst/>
                <a:latin typeface="Aptos" panose="020B0004020202020204" pitchFamily="34" charset="0"/>
                <a:ea typeface="DengXian" panose="02010600030101010101" pitchFamily="2" charset="-122"/>
                <a:cs typeface="Arial" panose="020B0604020202020204" pitchFamily="34" charset="0"/>
              </a:rPr>
              <a:t> in the dendrograms at the right of these “mass plots” further illustrate the dissimilarity of the infant serum.</a:t>
            </a:r>
          </a:p>
          <a:p>
            <a:r>
              <a:rPr lang="en-US" sz="1400" dirty="0">
                <a:latin typeface="Aptos" panose="020B0004020202020204" pitchFamily="34" charset="0"/>
                <a:ea typeface="DengXian" panose="02010600030101010101" pitchFamily="2" charset="-122"/>
                <a:cs typeface="Arial" panose="020B0604020202020204" pitchFamily="34" charset="0"/>
              </a:rPr>
              <a:t>In panel </a:t>
            </a:r>
            <a:r>
              <a:rPr lang="en-US" sz="1400" b="1" dirty="0">
                <a:latin typeface="Aptos" panose="020B0004020202020204" pitchFamily="34" charset="0"/>
                <a:ea typeface="DengXian" panose="02010600030101010101" pitchFamily="2" charset="-122"/>
                <a:cs typeface="Arial" panose="020B0604020202020204" pitchFamily="34" charset="0"/>
              </a:rPr>
              <a:t>d</a:t>
            </a:r>
            <a:r>
              <a:rPr lang="en-US" sz="1400" dirty="0">
                <a:latin typeface="Aptos" panose="020B0004020202020204" pitchFamily="34" charset="0"/>
                <a:ea typeface="DengXian" panose="02010600030101010101" pitchFamily="2" charset="-122"/>
                <a:cs typeface="Arial" panose="020B0604020202020204" pitchFamily="34" charset="0"/>
              </a:rPr>
              <a:t> we furthermore show the fraction of maternal (dark) or infant (light) origin in the infant T2 IgG1 repertoires.</a:t>
            </a:r>
            <a:endParaRPr lang="en-US" sz="1400" dirty="0"/>
          </a:p>
        </p:txBody>
      </p:sp>
    </p:spTree>
    <p:extLst>
      <p:ext uri="{BB962C8B-B14F-4D97-AF65-F5344CB8AC3E}">
        <p14:creationId xmlns:p14="http://schemas.microsoft.com/office/powerpoint/2010/main" val="104840497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338</Words>
  <Application>Microsoft Office PowerPoint</Application>
  <PresentationFormat>Widescreen</PresentationFormat>
  <Paragraphs>8</Paragraphs>
  <Slides>3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7" baseType="lpstr">
      <vt:lpstr>Aptos</vt:lpstr>
      <vt:lpstr>Aptos Display</vt:lpstr>
      <vt:lpstr>Arial</vt:lpstr>
      <vt:lpstr>Office Theme</vt:lpstr>
      <vt:lpstr>Supplemental Figures to: Dissecting infant and maternal antibody repertoires exposes the early onset of infant humoral immunity  Correspondence to Prof. Albert J.R. Heck (a.j.r.heck@uu.nl) or Prof. Juanjuan Guo (guojjhu@163.com) or Dr. Jing Zhu (zhujing@bjast.ac.cn)</vt:lpstr>
      <vt:lpstr>Supp Fig 1 – IgA1</vt:lpstr>
      <vt:lpstr>Supp fig 2 – IgG1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Rijswijck, D.M.H. van (Danique)</dc:creator>
  <cp:lastModifiedBy>Bondt, A. (Albert)</cp:lastModifiedBy>
  <cp:revision>4</cp:revision>
  <dcterms:created xsi:type="dcterms:W3CDTF">2025-08-01T13:01:12Z</dcterms:created>
  <dcterms:modified xsi:type="dcterms:W3CDTF">2025-12-10T16:06:55Z</dcterms:modified>
</cp:coreProperties>
</file>